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7DB8C4"/>
    <a:srgbClr val="F53333"/>
    <a:srgbClr val="7604F4"/>
    <a:srgbClr val="CB878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009"/>
    <p:restoredTop sz="94674"/>
  </p:normalViewPr>
  <p:slideViewPr>
    <p:cSldViewPr snapToGrid="0" snapToObjects="1" showGuides="1">
      <p:cViewPr varScale="1">
        <p:scale>
          <a:sx n="89" d="100"/>
          <a:sy n="89" d="100"/>
        </p:scale>
        <p:origin x="557" y="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7CAD1F3-8510-C745-8546-00CAB1B337B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A0762853-9EE8-9349-A921-A4633D034C5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4A1FF98-54E7-664B-9661-203FE92B7C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AB8F2-2F9B-9346-9C99-A00F94A713F2}" type="datetimeFigureOut">
              <a:rPr lang="en-GB" smtClean="0"/>
              <a:t>25/11/2021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35D671EB-787D-3544-AC69-A9469DEB02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739F0EE1-E837-CB4F-9A92-88431FD93D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1A814-CCAF-034E-A0D6-8E35709359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443064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BAD150D-CEE6-A044-9AC0-19A94717B3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27284AD5-4514-524F-8699-9D989530496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A87CD21-B3AE-C047-AD68-C261859568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AB8F2-2F9B-9346-9C99-A00F94A713F2}" type="datetimeFigureOut">
              <a:rPr lang="en-GB" smtClean="0"/>
              <a:t>25/11/2021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7D8C353-CF43-A941-AAA8-37F68EAFD1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73C9271-5B03-DC40-B49C-18044D660C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1A814-CCAF-034E-A0D6-8E35709359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366526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5BCC7ADE-D618-9442-AD0D-D3462345D27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EC106D36-E5E7-934D-99DB-33D590243C3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C5D0361-473A-714A-ABE7-BBC832F5B4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AB8F2-2F9B-9346-9C99-A00F94A713F2}" type="datetimeFigureOut">
              <a:rPr lang="en-GB" smtClean="0"/>
              <a:t>25/11/2021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6104938-FA45-2D4F-94AB-EF6389756B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FC6403B-668A-944F-BD7F-9F2D27867B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1A814-CCAF-034E-A0D6-8E35709359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767808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7E72390-AB16-3D41-97FA-014DF36811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2C4AA763-9B0B-FC44-9742-027D00DF56F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1AA3FB2-6E08-F54E-9388-640C0A3A9B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AB8F2-2F9B-9346-9C99-A00F94A713F2}" type="datetimeFigureOut">
              <a:rPr lang="en-GB" smtClean="0"/>
              <a:t>25/11/2021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7008BCD-68BB-3D4A-AAFD-775D7509A8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048D155-B4DE-994B-886B-839B312DD6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1A814-CCAF-034E-A0D6-8E35709359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551940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12EFD6A-1DF3-6545-BAFF-3BFFD4DBD3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8189EC4A-4F41-104B-A168-4B8F8C07456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7BD8304-95DD-1449-9AFB-DE90C297AD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AB8F2-2F9B-9346-9C99-A00F94A713F2}" type="datetimeFigureOut">
              <a:rPr lang="en-GB" smtClean="0"/>
              <a:t>25/11/2021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AB6046CF-D4E8-2848-834F-F864462591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DBA30FB6-2436-B648-A893-FF9D5CABC0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1A814-CCAF-034E-A0D6-8E35709359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22813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E0577A7-FAC2-AF4F-8EB6-8396371230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2CB867DF-2745-054C-B68F-3EC58B7906A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AF25E6F4-B988-664E-AFE6-B77B4A43CF1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33EDA203-5CA2-2640-BB27-EC6E3CAC07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AB8F2-2F9B-9346-9C99-A00F94A713F2}" type="datetimeFigureOut">
              <a:rPr lang="en-GB" smtClean="0"/>
              <a:t>25/11/2021</a:t>
            </a:fld>
            <a:endParaRPr lang="en-GB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486DF5B9-7285-FC41-BF16-AABB46FEB1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F9A87BB5-0584-9740-A4D6-62273A0E3F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1A814-CCAF-034E-A0D6-8E35709359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82982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87B5CFB-3619-434D-9489-5FD71BFCCD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147BB320-8AD2-D140-AB6E-A6483546933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68C1B3AF-4F32-D648-877A-3BD61F6E959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87D73065-57D2-1B44-BE2E-0A30299AD81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923A9B27-348A-3840-9E48-6A8583E192E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6865298F-F241-804B-8C46-27539660F7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AB8F2-2F9B-9346-9C99-A00F94A713F2}" type="datetimeFigureOut">
              <a:rPr lang="en-GB" smtClean="0"/>
              <a:t>25/11/2021</a:t>
            </a:fld>
            <a:endParaRPr lang="en-GB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47BBF7E3-F666-B34D-B78F-1C18389000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CDD4EC22-F0B9-BC4F-830B-5BAE2227E5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1A814-CCAF-034E-A0D6-8E35709359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065815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8504930-C194-BE49-B30F-30FABAC537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67D8D533-4720-B443-B66C-E1BF459214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AB8F2-2F9B-9346-9C99-A00F94A713F2}" type="datetimeFigureOut">
              <a:rPr lang="en-GB" smtClean="0"/>
              <a:t>25/11/2021</a:t>
            </a:fld>
            <a:endParaRPr lang="en-GB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5E6177AF-A937-D344-8AD3-0FC5BB7918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D9A2941F-9AD6-3C4A-A9EF-0B7119DFC4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1A814-CCAF-034E-A0D6-8E35709359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425352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3D4CB7C9-BAEB-EF4E-9815-23CD5FA031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AB8F2-2F9B-9346-9C99-A00F94A713F2}" type="datetimeFigureOut">
              <a:rPr lang="en-GB" smtClean="0"/>
              <a:t>25/11/2021</a:t>
            </a:fld>
            <a:endParaRPr lang="en-GB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D773B82D-9D57-1D4E-80A6-C31A82B9ED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6337481C-5349-764C-AADE-3B295891EE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1A814-CCAF-034E-A0D6-8E35709359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428607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448B284-8BFC-214A-9534-BDF8BC4DFB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146B220C-D2BF-F44E-86A7-D1E9EE64D97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4B19E513-9498-E344-A5CB-FEC8A622064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FD3C9FBB-4C81-CD4E-919F-88D72046BB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AB8F2-2F9B-9346-9C99-A00F94A713F2}" type="datetimeFigureOut">
              <a:rPr lang="en-GB" smtClean="0"/>
              <a:t>25/11/2021</a:t>
            </a:fld>
            <a:endParaRPr lang="en-GB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0BFF7F95-DB1D-A845-A61A-F559DDB906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294AFD71-2DCE-7D41-836F-3385551256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1A814-CCAF-034E-A0D6-8E35709359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515247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70C9BAA-4825-B340-9F43-45C11404BC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702A971D-C0DB-324E-8F64-62BAA090E96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586917AD-E533-3E47-9AAF-016FA79E96E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7F5BEB11-F92E-B645-AB4E-0313D9F129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AB8F2-2F9B-9346-9C99-A00F94A713F2}" type="datetimeFigureOut">
              <a:rPr lang="en-GB" smtClean="0"/>
              <a:t>25/11/2021</a:t>
            </a:fld>
            <a:endParaRPr lang="en-GB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4696129E-A6F3-324A-BD65-3E28D4B31D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A86162AD-2BA5-DE40-98D8-5650BDAC3F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1A814-CCAF-034E-A0D6-8E35709359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56880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D2159464-74AE-CE42-9C17-EE38A1AC6B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1CF3612B-0EC9-3F46-9E8B-6AF610A5497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8898786-2279-9442-9A94-BDB5C8CFAB2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9AB8F2-2F9B-9346-9C99-A00F94A713F2}" type="datetimeFigureOut">
              <a:rPr lang="en-GB" smtClean="0"/>
              <a:t>25/11/2021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8ACC6B7-34BF-FF43-B5FF-0E741AC5932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49297CA-F417-174E-B500-F4C426C8A68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21A814-CCAF-034E-A0D6-8E35709359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870661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Immagine 12">
            <a:extLst>
              <a:ext uri="{FF2B5EF4-FFF2-40B4-BE49-F238E27FC236}">
                <a16:creationId xmlns:a16="http://schemas.microsoft.com/office/drawing/2014/main" id="{E69FD7B7-AB00-CA49-842B-5A2BBD369D6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13679"/>
          <a:stretch/>
        </p:blipFill>
        <p:spPr>
          <a:xfrm>
            <a:off x="81913" y="772778"/>
            <a:ext cx="10382887" cy="5312443"/>
          </a:xfrm>
          <a:prstGeom prst="rect">
            <a:avLst/>
          </a:prstGeom>
        </p:spPr>
      </p:pic>
      <p:sp>
        <p:nvSpPr>
          <p:cNvPr id="14" name="Rettangolo 13">
            <a:extLst>
              <a:ext uri="{FF2B5EF4-FFF2-40B4-BE49-F238E27FC236}">
                <a16:creationId xmlns:a16="http://schemas.microsoft.com/office/drawing/2014/main" id="{FBF0E128-CC81-7C40-9BB3-EF21DD10BE07}"/>
              </a:ext>
            </a:extLst>
          </p:cNvPr>
          <p:cNvSpPr/>
          <p:nvPr/>
        </p:nvSpPr>
        <p:spPr>
          <a:xfrm>
            <a:off x="10260804" y="4023278"/>
            <a:ext cx="1778795" cy="1425407"/>
          </a:xfrm>
          <a:prstGeom prst="rect">
            <a:avLst/>
          </a:prstGeom>
          <a:noFill/>
          <a:ln w="12700" cap="flat">
            <a:solidFill>
              <a:schemeClr val="tx1"/>
            </a:solidFill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35B18DBA-D602-944C-8614-72FBF23C047D}"/>
              </a:ext>
            </a:extLst>
          </p:cNvPr>
          <p:cNvSpPr txBox="1"/>
          <p:nvPr/>
        </p:nvSpPr>
        <p:spPr>
          <a:xfrm>
            <a:off x="10850880" y="4331394"/>
            <a:ext cx="1209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i="1" dirty="0"/>
              <a:t>O. mykiss</a:t>
            </a:r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B27429B3-5942-A841-8ECB-FD761C2AB9B3}"/>
              </a:ext>
            </a:extLst>
          </p:cNvPr>
          <p:cNvSpPr txBox="1"/>
          <p:nvPr/>
        </p:nvSpPr>
        <p:spPr>
          <a:xfrm>
            <a:off x="10850880" y="4608393"/>
            <a:ext cx="1209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i="1" dirty="0"/>
              <a:t>D. rerio</a:t>
            </a:r>
          </a:p>
        </p:txBody>
      </p:sp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9F553480-20AD-744D-A027-38F06569C585}"/>
              </a:ext>
            </a:extLst>
          </p:cNvPr>
          <p:cNvSpPr txBox="1"/>
          <p:nvPr/>
        </p:nvSpPr>
        <p:spPr>
          <a:xfrm>
            <a:off x="10850880" y="4885392"/>
            <a:ext cx="1209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i="1" dirty="0"/>
              <a:t>H. sapiens</a:t>
            </a:r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4216A661-28F2-174E-A930-250A7F3CAED4}"/>
              </a:ext>
            </a:extLst>
          </p:cNvPr>
          <p:cNvSpPr txBox="1"/>
          <p:nvPr/>
        </p:nvSpPr>
        <p:spPr>
          <a:xfrm>
            <a:off x="10850880" y="5171686"/>
            <a:ext cx="1209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i="1" dirty="0"/>
              <a:t>O. tshawytscha</a:t>
            </a:r>
          </a:p>
        </p:txBody>
      </p:sp>
      <p:cxnSp>
        <p:nvCxnSpPr>
          <p:cNvPr id="20" name="Connettore 1 19">
            <a:extLst>
              <a:ext uri="{FF2B5EF4-FFF2-40B4-BE49-F238E27FC236}">
                <a16:creationId xmlns:a16="http://schemas.microsoft.com/office/drawing/2014/main" id="{90C3190B-AA64-5446-8045-4A06B355A5E5}"/>
              </a:ext>
            </a:extLst>
          </p:cNvPr>
          <p:cNvCxnSpPr>
            <a:endCxn id="15" idx="1"/>
          </p:cNvCxnSpPr>
          <p:nvPr/>
        </p:nvCxnSpPr>
        <p:spPr>
          <a:xfrm>
            <a:off x="10312400" y="4469893"/>
            <a:ext cx="538480" cy="1"/>
          </a:xfrm>
          <a:prstGeom prst="line">
            <a:avLst/>
          </a:prstGeom>
          <a:ln w="28575">
            <a:solidFill>
              <a:srgbClr val="CB8787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Connettore 1 20">
            <a:extLst>
              <a:ext uri="{FF2B5EF4-FFF2-40B4-BE49-F238E27FC236}">
                <a16:creationId xmlns:a16="http://schemas.microsoft.com/office/drawing/2014/main" id="{3C6D6166-9E75-224C-89AF-E9205441D169}"/>
              </a:ext>
            </a:extLst>
          </p:cNvPr>
          <p:cNvCxnSpPr/>
          <p:nvPr/>
        </p:nvCxnSpPr>
        <p:spPr>
          <a:xfrm>
            <a:off x="10312400" y="4746892"/>
            <a:ext cx="538480" cy="1"/>
          </a:xfrm>
          <a:prstGeom prst="line">
            <a:avLst/>
          </a:prstGeom>
          <a:ln w="28575">
            <a:solidFill>
              <a:srgbClr val="7604F4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Connettore 1 21">
            <a:extLst>
              <a:ext uri="{FF2B5EF4-FFF2-40B4-BE49-F238E27FC236}">
                <a16:creationId xmlns:a16="http://schemas.microsoft.com/office/drawing/2014/main" id="{D6CEC00F-26AD-A244-8720-086F5733469A}"/>
              </a:ext>
            </a:extLst>
          </p:cNvPr>
          <p:cNvCxnSpPr/>
          <p:nvPr/>
        </p:nvCxnSpPr>
        <p:spPr>
          <a:xfrm>
            <a:off x="10312400" y="5023890"/>
            <a:ext cx="538480" cy="1"/>
          </a:xfrm>
          <a:prstGeom prst="line">
            <a:avLst/>
          </a:prstGeom>
          <a:ln w="28575">
            <a:solidFill>
              <a:srgbClr val="F53333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Connettore 1 22">
            <a:extLst>
              <a:ext uri="{FF2B5EF4-FFF2-40B4-BE49-F238E27FC236}">
                <a16:creationId xmlns:a16="http://schemas.microsoft.com/office/drawing/2014/main" id="{57665C00-8753-5E4A-BD84-5B5571C629CB}"/>
              </a:ext>
            </a:extLst>
          </p:cNvPr>
          <p:cNvCxnSpPr/>
          <p:nvPr/>
        </p:nvCxnSpPr>
        <p:spPr>
          <a:xfrm>
            <a:off x="10312400" y="5330684"/>
            <a:ext cx="538480" cy="1"/>
          </a:xfrm>
          <a:prstGeom prst="line">
            <a:avLst/>
          </a:prstGeom>
          <a:ln w="28575">
            <a:solidFill>
              <a:srgbClr val="7DB8C4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CasellaDiTesto 23">
            <a:extLst>
              <a:ext uri="{FF2B5EF4-FFF2-40B4-BE49-F238E27FC236}">
                <a16:creationId xmlns:a16="http://schemas.microsoft.com/office/drawing/2014/main" id="{40E1F3B9-B41C-3844-B666-6190190296B6}"/>
              </a:ext>
            </a:extLst>
          </p:cNvPr>
          <p:cNvSpPr txBox="1"/>
          <p:nvPr/>
        </p:nvSpPr>
        <p:spPr>
          <a:xfrm>
            <a:off x="10260803" y="4023278"/>
            <a:ext cx="17787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FP rate= 5.0%</a:t>
            </a:r>
          </a:p>
        </p:txBody>
      </p:sp>
      <p:sp>
        <p:nvSpPr>
          <p:cNvPr id="19" name="Rechteck 18"/>
          <p:cNvSpPr/>
          <p:nvPr/>
        </p:nvSpPr>
        <p:spPr>
          <a:xfrm>
            <a:off x="351692" y="6220534"/>
            <a:ext cx="10240107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900" b="1" dirty="0">
                <a:latin typeface="Palatino Linotype" panose="02040502050505030304" pitchFamily="18" charset="0"/>
              </a:rPr>
              <a:t>Figure S4: </a:t>
            </a:r>
            <a:r>
              <a:rPr lang="en-US" sz="900" dirty="0">
                <a:latin typeface="Palatino Linotype" panose="02040502050505030304" pitchFamily="18" charset="0"/>
              </a:rPr>
              <a:t>Comparison of disordered regions in </a:t>
            </a:r>
            <a:r>
              <a:rPr lang="en-US" sz="900" dirty="0" err="1">
                <a:latin typeface="Palatino Linotype" panose="02040502050505030304" pitchFamily="18" charset="0"/>
              </a:rPr>
              <a:t>Pias</a:t>
            </a:r>
            <a:r>
              <a:rPr lang="en-US" sz="900" dirty="0">
                <a:latin typeface="Palatino Linotype" panose="02040502050505030304" pitchFamily="18" charset="0"/>
              </a:rPr>
              <a:t> proteins from different vertebrate species </a:t>
            </a:r>
            <a:r>
              <a:rPr lang="de-DE" sz="900" dirty="0" err="1">
                <a:latin typeface="Palatino Linotype" panose="02040502050505030304" pitchFamily="18" charset="0"/>
              </a:rPr>
              <a:t>as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indicate</a:t>
            </a:r>
            <a:r>
              <a:rPr lang="de-DE" sz="900" dirty="0">
                <a:latin typeface="Palatino Linotype" panose="02040502050505030304" pitchFamily="18" charset="0"/>
              </a:rPr>
              <a:t> in </a:t>
            </a:r>
            <a:r>
              <a:rPr lang="de-DE" sz="900" dirty="0" err="1">
                <a:latin typeface="Palatino Linotype" panose="02040502050505030304" pitchFamily="18" charset="0"/>
              </a:rPr>
              <a:t>the</a:t>
            </a:r>
            <a:r>
              <a:rPr lang="de-DE" sz="900" dirty="0">
                <a:latin typeface="Palatino Linotype" panose="02040502050505030304" pitchFamily="18" charset="0"/>
              </a:rPr>
              <a:t> legend at </a:t>
            </a:r>
            <a:r>
              <a:rPr lang="de-DE" sz="900" dirty="0" err="1">
                <a:latin typeface="Palatino Linotype" panose="02040502050505030304" pitchFamily="18" charset="0"/>
              </a:rPr>
              <a:t>the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right</a:t>
            </a:r>
            <a:r>
              <a:rPr lang="de-DE" sz="900" dirty="0">
                <a:latin typeface="Palatino Linotype" panose="02040502050505030304" pitchFamily="18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336286627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0</Words>
  <Application>Microsoft Office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Tema di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Utente di Microsoft Office</dc:creator>
  <cp:lastModifiedBy>MDPI-118</cp:lastModifiedBy>
  <cp:revision>5</cp:revision>
  <dcterms:created xsi:type="dcterms:W3CDTF">2020-10-07T12:44:39Z</dcterms:created>
  <dcterms:modified xsi:type="dcterms:W3CDTF">2021-11-25T17:07:36Z</dcterms:modified>
</cp:coreProperties>
</file>